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  <p:sldId id="262" r:id="rId3"/>
    <p:sldId id="263" r:id="rId4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3"/>
    <p:restoredTop sz="94693"/>
  </p:normalViewPr>
  <p:slideViewPr>
    <p:cSldViewPr snapToGrid="0" snapToObjects="1">
      <p:cViewPr varScale="1">
        <p:scale>
          <a:sx n="78" d="100"/>
          <a:sy n="78" d="100"/>
        </p:scale>
        <p:origin x="28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061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5876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4406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898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6868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819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418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9488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4183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390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1548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983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Relationship Id="rId3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tiff"/><Relationship Id="rId3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tiff"/><Relationship Id="rId3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555585" y="394504"/>
            <a:ext cx="5764193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ource File 1B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ssociated with Figure 3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Nkx2.2</a:t>
            </a:r>
            <a:r>
              <a:rPr lang="en-US" sz="1300" baseline="300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300" baseline="30000" dirty="0">
                <a:latin typeface="Arial" panose="020B0604020202020204" pitchFamily="34" charset="0"/>
                <a:cs typeface="Arial" panose="020B0604020202020204" pitchFamily="34" charset="0"/>
              </a:rPr>
              <a:t>endo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and Nkx2.2</a:t>
            </a:r>
            <a:r>
              <a:rPr lang="en-US" sz="1300" baseline="300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E15.5 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RNA-</a:t>
            </a:r>
            <a:r>
              <a:rPr lang="en-US" sz="13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: Genes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showing 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significant differential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expression in only Nkx2.2</a:t>
            </a:r>
            <a:r>
              <a:rPr lang="en-US" sz="1300" baseline="300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mice (325 genes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  <a:p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Page 1 of 4</a:t>
            </a:r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2" descr="C:\Users\Angela\Documents\NYC\Sussel Lab\EPKO\EPKO Paper Figures\Supp Table 3_Page_1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61" t="7842" r="67046" b="9069"/>
          <a:stretch/>
        </p:blipFill>
        <p:spPr bwMode="auto">
          <a:xfrm>
            <a:off x="732581" y="1716912"/>
            <a:ext cx="2705100" cy="6457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2" descr="C:\Users\Angela\Documents\NYC\Sussel Lab\EPKO\EPKO Paper Figures\Supp Table 3_Page_2.ti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82" t="7353" r="67045" b="7598"/>
          <a:stretch/>
        </p:blipFill>
        <p:spPr bwMode="auto">
          <a:xfrm>
            <a:off x="3437681" y="1640712"/>
            <a:ext cx="2743200" cy="6610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981428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555585" y="394504"/>
            <a:ext cx="5764193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ource File 1B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ssociated with 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Nkx2.2</a:t>
            </a:r>
            <a:r>
              <a:rPr lang="en-US" sz="1300" baseline="300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300" baseline="30000" dirty="0">
                <a:latin typeface="Arial" panose="020B0604020202020204" pitchFamily="34" charset="0"/>
                <a:cs typeface="Arial" panose="020B0604020202020204" pitchFamily="34" charset="0"/>
              </a:rPr>
              <a:t>endo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and Nkx2.2</a:t>
            </a:r>
            <a:r>
              <a:rPr lang="en-US" sz="1300" baseline="300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E15.5 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RNA-</a:t>
            </a:r>
            <a:r>
              <a:rPr lang="en-US" sz="13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: Genes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showing 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significant differential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expression in only Nkx2.2</a:t>
            </a:r>
            <a:r>
              <a:rPr lang="en-US" sz="1300" baseline="300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mice (325 genes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  <a:p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Page 2 of 4</a:t>
            </a:r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2" descr="C:\Users\Angela\Documents\NYC\Sussel Lab\EPKO\EPKO Paper Figures\Supp Table 3_Page_3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71" t="8164" r="67614" b="8333"/>
          <a:stretch/>
        </p:blipFill>
        <p:spPr bwMode="auto">
          <a:xfrm>
            <a:off x="640466" y="1944144"/>
            <a:ext cx="2667000" cy="64901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 descr="C:\Users\Angela\Documents\NYC\Sussel Lab\EPKO\EPKO Paper Figures\Supp Table 3_Page_4.ti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82" t="7428" r="67235" b="7843"/>
          <a:stretch/>
        </p:blipFill>
        <p:spPr bwMode="auto">
          <a:xfrm>
            <a:off x="3437681" y="1896519"/>
            <a:ext cx="2724150" cy="65854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6006949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555585" y="394504"/>
            <a:ext cx="5764193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ource File 1B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ssociated with Figure 3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Nkx2.2</a:t>
            </a:r>
            <a:r>
              <a:rPr lang="en-US" sz="1300" baseline="300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300" baseline="30000" dirty="0">
                <a:latin typeface="Arial" panose="020B0604020202020204" pitchFamily="34" charset="0"/>
                <a:cs typeface="Arial" panose="020B0604020202020204" pitchFamily="34" charset="0"/>
              </a:rPr>
              <a:t>endo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and Nkx2.2</a:t>
            </a:r>
            <a:r>
              <a:rPr lang="en-US" sz="1300" baseline="300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E15.5 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RNA-</a:t>
            </a:r>
            <a:r>
              <a:rPr lang="en-US" sz="13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: Genes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showing 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significant differential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expression in only Nkx2.2</a:t>
            </a:r>
            <a:r>
              <a:rPr lang="en-US" sz="1300" baseline="300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mice (325 genes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  <a:p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Page 4 of 4</a:t>
            </a:r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2" descr="C:\Users\Angela\Documents\NYC\Sussel Lab\EPKO\EPKO Paper Figures\Supp Table 3_Page_7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03" t="7843" r="67045" b="7843"/>
          <a:stretch/>
        </p:blipFill>
        <p:spPr bwMode="auto">
          <a:xfrm>
            <a:off x="555585" y="1855940"/>
            <a:ext cx="2781300" cy="6553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Angela\Documents\NYC\Sussel Lab\EPKO\EPKO Paper Figures\Supp Table 3_Page_8.ti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03" t="7355" r="66667" b="7598"/>
          <a:stretch/>
        </p:blipFill>
        <p:spPr bwMode="auto">
          <a:xfrm>
            <a:off x="3717885" y="1844957"/>
            <a:ext cx="2819400" cy="6610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524459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93</Words>
  <Application>Microsoft Macintosh PowerPoint</Application>
  <PresentationFormat>Letter Paper (8.5x11 in)</PresentationFormat>
  <Paragraphs>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Calibri</vt:lpstr>
      <vt:lpstr>Calibri Light</vt:lpstr>
      <vt:lpstr>Symbol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2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2</cp:revision>
  <dcterms:created xsi:type="dcterms:W3CDTF">2016-08-03T22:46:02Z</dcterms:created>
  <dcterms:modified xsi:type="dcterms:W3CDTF">2016-08-04T16:50:53Z</dcterms:modified>
</cp:coreProperties>
</file>